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30603825" cy="14401800"/>
  <p:notesSz cx="6858000" cy="9144000"/>
  <p:defaultTextStyle>
    <a:defPPr>
      <a:defRPr lang="cs-CZ"/>
    </a:defPPr>
    <a:lvl1pPr marL="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1pPr>
    <a:lvl2pPr marL="128587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2pPr>
    <a:lvl3pPr marL="257175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3pPr>
    <a:lvl4pPr marL="385762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4pPr>
    <a:lvl5pPr marL="514350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5pPr>
    <a:lvl6pPr marL="642937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6pPr>
    <a:lvl7pPr marL="771525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7pPr>
    <a:lvl8pPr marL="900112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8pPr>
    <a:lvl9pPr marL="1028700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30" d="100"/>
          <a:sy n="30" d="100"/>
        </p:scale>
        <p:origin x="-402" y="-126"/>
      </p:cViewPr>
      <p:guideLst>
        <p:guide orient="horz" pos="4536"/>
        <p:guide pos="96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2295287" y="4473893"/>
            <a:ext cx="26013251" cy="308705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4590574" y="8161020"/>
            <a:ext cx="21422678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285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717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5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143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4293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7152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0011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287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30460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51357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74262097" y="1210153"/>
            <a:ext cx="23043191" cy="2580655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5121890" y="1210153"/>
            <a:ext cx="68630142" cy="2580655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92007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01632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2417491" y="9254491"/>
            <a:ext cx="26013251" cy="2860358"/>
          </a:xfrm>
        </p:spPr>
        <p:txBody>
          <a:bodyPr anchor="t"/>
          <a:lstStyle>
            <a:lvl1pPr algn="l">
              <a:defRPr sz="113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2417491" y="6104098"/>
            <a:ext cx="26013251" cy="3150393"/>
          </a:xfrm>
        </p:spPr>
        <p:txBody>
          <a:bodyPr anchor="b"/>
          <a:lstStyle>
            <a:lvl1pPr marL="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1pPr>
            <a:lvl2pPr marL="1285875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2pPr>
            <a:lvl3pPr marL="257175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85762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4pPr>
            <a:lvl5pPr marL="514350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5pPr>
            <a:lvl6pPr marL="642937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6pPr>
            <a:lvl7pPr marL="771525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7pPr>
            <a:lvl8pPr marL="900112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8pPr>
            <a:lvl9pPr marL="1028700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49714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5121892" y="7057550"/>
            <a:ext cx="45836668" cy="1995916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6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51468622" y="7057550"/>
            <a:ext cx="45836665" cy="1995916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6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88047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530191" y="576740"/>
            <a:ext cx="27543443" cy="2400300"/>
          </a:xfrm>
        </p:spPr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1530191" y="3223737"/>
            <a:ext cx="13522004" cy="1343500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85875" indent="0">
              <a:buNone/>
              <a:defRPr sz="5600" b="1"/>
            </a:lvl2pPr>
            <a:lvl3pPr marL="2571750" indent="0">
              <a:buNone/>
              <a:defRPr sz="5100" b="1"/>
            </a:lvl3pPr>
            <a:lvl4pPr marL="3857625" indent="0">
              <a:buNone/>
              <a:defRPr sz="4500" b="1"/>
            </a:lvl4pPr>
            <a:lvl5pPr marL="5143500" indent="0">
              <a:buNone/>
              <a:defRPr sz="4500" b="1"/>
            </a:lvl5pPr>
            <a:lvl6pPr marL="6429375" indent="0">
              <a:buNone/>
              <a:defRPr sz="4500" b="1"/>
            </a:lvl6pPr>
            <a:lvl7pPr marL="7715250" indent="0">
              <a:buNone/>
              <a:defRPr sz="4500" b="1"/>
            </a:lvl7pPr>
            <a:lvl8pPr marL="9001125" indent="0">
              <a:buNone/>
              <a:defRPr sz="4500" b="1"/>
            </a:lvl8pPr>
            <a:lvl9pPr marL="10287000" indent="0">
              <a:buNone/>
              <a:defRPr sz="45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1530191" y="4567237"/>
            <a:ext cx="13522004" cy="8297705"/>
          </a:xfrm>
        </p:spPr>
        <p:txBody>
          <a:bodyPr/>
          <a:lstStyle>
            <a:lvl1pPr>
              <a:defRPr sz="6800"/>
            </a:lvl1pPr>
            <a:lvl2pPr>
              <a:defRPr sz="56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15546320" y="3223737"/>
            <a:ext cx="13527316" cy="1343500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85875" indent="0">
              <a:buNone/>
              <a:defRPr sz="5600" b="1"/>
            </a:lvl2pPr>
            <a:lvl3pPr marL="2571750" indent="0">
              <a:buNone/>
              <a:defRPr sz="5100" b="1"/>
            </a:lvl3pPr>
            <a:lvl4pPr marL="3857625" indent="0">
              <a:buNone/>
              <a:defRPr sz="4500" b="1"/>
            </a:lvl4pPr>
            <a:lvl5pPr marL="5143500" indent="0">
              <a:buNone/>
              <a:defRPr sz="4500" b="1"/>
            </a:lvl5pPr>
            <a:lvl6pPr marL="6429375" indent="0">
              <a:buNone/>
              <a:defRPr sz="4500" b="1"/>
            </a:lvl6pPr>
            <a:lvl7pPr marL="7715250" indent="0">
              <a:buNone/>
              <a:defRPr sz="4500" b="1"/>
            </a:lvl7pPr>
            <a:lvl8pPr marL="9001125" indent="0">
              <a:buNone/>
              <a:defRPr sz="4500" b="1"/>
            </a:lvl8pPr>
            <a:lvl9pPr marL="10287000" indent="0">
              <a:buNone/>
              <a:defRPr sz="45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15546320" y="4567237"/>
            <a:ext cx="13527316" cy="8297705"/>
          </a:xfrm>
        </p:spPr>
        <p:txBody>
          <a:bodyPr/>
          <a:lstStyle>
            <a:lvl1pPr>
              <a:defRPr sz="6800"/>
            </a:lvl1pPr>
            <a:lvl2pPr>
              <a:defRPr sz="56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447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53486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81790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530193" y="573405"/>
            <a:ext cx="10068448" cy="2440305"/>
          </a:xfrm>
        </p:spPr>
        <p:txBody>
          <a:bodyPr anchor="b"/>
          <a:lstStyle>
            <a:lvl1pPr algn="l">
              <a:defRPr sz="56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11965246" y="573406"/>
            <a:ext cx="17108388" cy="12291537"/>
          </a:xfrm>
        </p:spPr>
        <p:txBody>
          <a:bodyPr/>
          <a:lstStyle>
            <a:lvl1pPr>
              <a:defRPr sz="9000"/>
            </a:lvl1pPr>
            <a:lvl2pPr>
              <a:defRPr sz="7900"/>
            </a:lvl2pPr>
            <a:lvl3pPr>
              <a:defRPr sz="6800"/>
            </a:lvl3pPr>
            <a:lvl4pPr>
              <a:defRPr sz="5600"/>
            </a:lvl4pPr>
            <a:lvl5pPr>
              <a:defRPr sz="5600"/>
            </a:lvl5pPr>
            <a:lvl6pPr>
              <a:defRPr sz="5600"/>
            </a:lvl6pPr>
            <a:lvl7pPr>
              <a:defRPr sz="5600"/>
            </a:lvl7pPr>
            <a:lvl8pPr>
              <a:defRPr sz="5600"/>
            </a:lvl8pPr>
            <a:lvl9pPr>
              <a:defRPr sz="5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530193" y="3013711"/>
            <a:ext cx="10068448" cy="9851232"/>
          </a:xfrm>
        </p:spPr>
        <p:txBody>
          <a:bodyPr/>
          <a:lstStyle>
            <a:lvl1pPr marL="0" indent="0">
              <a:buNone/>
              <a:defRPr sz="3900"/>
            </a:lvl1pPr>
            <a:lvl2pPr marL="1285875" indent="0">
              <a:buNone/>
              <a:defRPr sz="3400"/>
            </a:lvl2pPr>
            <a:lvl3pPr marL="2571750" indent="0">
              <a:buNone/>
              <a:defRPr sz="2800"/>
            </a:lvl3pPr>
            <a:lvl4pPr marL="3857625" indent="0">
              <a:buNone/>
              <a:defRPr sz="2500"/>
            </a:lvl4pPr>
            <a:lvl5pPr marL="5143500" indent="0">
              <a:buNone/>
              <a:defRPr sz="2500"/>
            </a:lvl5pPr>
            <a:lvl6pPr marL="6429375" indent="0">
              <a:buNone/>
              <a:defRPr sz="2500"/>
            </a:lvl6pPr>
            <a:lvl7pPr marL="7715250" indent="0">
              <a:buNone/>
              <a:defRPr sz="2500"/>
            </a:lvl7pPr>
            <a:lvl8pPr marL="9001125" indent="0">
              <a:buNone/>
              <a:defRPr sz="2500"/>
            </a:lvl8pPr>
            <a:lvl9pPr marL="10287000" indent="0">
              <a:buNone/>
              <a:defRPr sz="2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175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5998564" y="10081260"/>
            <a:ext cx="18362295" cy="1190150"/>
          </a:xfrm>
        </p:spPr>
        <p:txBody>
          <a:bodyPr anchor="b"/>
          <a:lstStyle>
            <a:lvl1pPr algn="l">
              <a:defRPr sz="56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5998564" y="1286828"/>
            <a:ext cx="18362295" cy="8641080"/>
          </a:xfrm>
        </p:spPr>
        <p:txBody>
          <a:bodyPr/>
          <a:lstStyle>
            <a:lvl1pPr marL="0" indent="0">
              <a:buNone/>
              <a:defRPr sz="9000"/>
            </a:lvl1pPr>
            <a:lvl2pPr marL="1285875" indent="0">
              <a:buNone/>
              <a:defRPr sz="7900"/>
            </a:lvl2pPr>
            <a:lvl3pPr marL="2571750" indent="0">
              <a:buNone/>
              <a:defRPr sz="6800"/>
            </a:lvl3pPr>
            <a:lvl4pPr marL="3857625" indent="0">
              <a:buNone/>
              <a:defRPr sz="5600"/>
            </a:lvl4pPr>
            <a:lvl5pPr marL="5143500" indent="0">
              <a:buNone/>
              <a:defRPr sz="5600"/>
            </a:lvl5pPr>
            <a:lvl6pPr marL="6429375" indent="0">
              <a:buNone/>
              <a:defRPr sz="5600"/>
            </a:lvl6pPr>
            <a:lvl7pPr marL="7715250" indent="0">
              <a:buNone/>
              <a:defRPr sz="5600"/>
            </a:lvl7pPr>
            <a:lvl8pPr marL="9001125" indent="0">
              <a:buNone/>
              <a:defRPr sz="5600"/>
            </a:lvl8pPr>
            <a:lvl9pPr marL="10287000" indent="0">
              <a:buNone/>
              <a:defRPr sz="56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5998564" y="11271410"/>
            <a:ext cx="18362295" cy="1690210"/>
          </a:xfrm>
        </p:spPr>
        <p:txBody>
          <a:bodyPr/>
          <a:lstStyle>
            <a:lvl1pPr marL="0" indent="0">
              <a:buNone/>
              <a:defRPr sz="3900"/>
            </a:lvl1pPr>
            <a:lvl2pPr marL="1285875" indent="0">
              <a:buNone/>
              <a:defRPr sz="3400"/>
            </a:lvl2pPr>
            <a:lvl3pPr marL="2571750" indent="0">
              <a:buNone/>
              <a:defRPr sz="2800"/>
            </a:lvl3pPr>
            <a:lvl4pPr marL="3857625" indent="0">
              <a:buNone/>
              <a:defRPr sz="2500"/>
            </a:lvl4pPr>
            <a:lvl5pPr marL="5143500" indent="0">
              <a:buNone/>
              <a:defRPr sz="2500"/>
            </a:lvl5pPr>
            <a:lvl6pPr marL="6429375" indent="0">
              <a:buNone/>
              <a:defRPr sz="2500"/>
            </a:lvl6pPr>
            <a:lvl7pPr marL="7715250" indent="0">
              <a:buNone/>
              <a:defRPr sz="2500"/>
            </a:lvl7pPr>
            <a:lvl8pPr marL="9001125" indent="0">
              <a:buNone/>
              <a:defRPr sz="2500"/>
            </a:lvl8pPr>
            <a:lvl9pPr marL="10287000" indent="0">
              <a:buNone/>
              <a:defRPr sz="2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62767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1530191" y="576740"/>
            <a:ext cx="27543443" cy="2400300"/>
          </a:xfrm>
          <a:prstGeom prst="rect">
            <a:avLst/>
          </a:prstGeom>
        </p:spPr>
        <p:txBody>
          <a:bodyPr vert="horz" lIns="257175" tIns="128588" rIns="257175" bIns="128588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1530191" y="3360421"/>
            <a:ext cx="27543443" cy="9504522"/>
          </a:xfrm>
          <a:prstGeom prst="rect">
            <a:avLst/>
          </a:prstGeom>
        </p:spPr>
        <p:txBody>
          <a:bodyPr vert="horz" lIns="257175" tIns="128588" rIns="257175" bIns="128588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1530191" y="13348336"/>
            <a:ext cx="7140893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l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8027C-770F-44D0-94F1-CAB13E77BBA3}" type="datetimeFigureOut">
              <a:rPr lang="cs-CZ" smtClean="0"/>
              <a:t>4.9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10456307" y="13348336"/>
            <a:ext cx="9691211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ct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21932741" y="13348336"/>
            <a:ext cx="7140893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10788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571750" rtl="0" eaLnBrk="1" latinLnBrk="0" hangingPunct="1">
        <a:spcBef>
          <a:spcPct val="0"/>
        </a:spcBef>
        <a:buNone/>
        <a:defRPr sz="12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64406" indent="-964406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1pPr>
      <a:lvl2pPr marL="2089547" indent="-803672" algn="l" defTabSz="2571750" rtl="0" eaLnBrk="1" latinLnBrk="0" hangingPunct="1">
        <a:spcBef>
          <a:spcPct val="20000"/>
        </a:spcBef>
        <a:buFont typeface="Arial" panose="020B0604020202020204" pitchFamily="34" charset="0"/>
        <a:buChar char="–"/>
        <a:defRPr sz="7900" kern="1200">
          <a:solidFill>
            <a:schemeClr val="tx1"/>
          </a:solidFill>
          <a:latin typeface="+mn-lt"/>
          <a:ea typeface="+mn-ea"/>
          <a:cs typeface="+mn-cs"/>
        </a:defRPr>
      </a:lvl2pPr>
      <a:lvl3pPr marL="321468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6800" kern="1200">
          <a:solidFill>
            <a:schemeClr val="tx1"/>
          </a:solidFill>
          <a:latin typeface="+mn-lt"/>
          <a:ea typeface="+mn-ea"/>
          <a:cs typeface="+mn-cs"/>
        </a:defRPr>
      </a:lvl3pPr>
      <a:lvl4pPr marL="450056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4pPr>
      <a:lvl5pPr marL="578643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»"/>
        <a:defRPr sz="5600" kern="1200">
          <a:solidFill>
            <a:schemeClr val="tx1"/>
          </a:solidFill>
          <a:latin typeface="+mn-lt"/>
          <a:ea typeface="+mn-ea"/>
          <a:cs typeface="+mn-cs"/>
        </a:defRPr>
      </a:lvl5pPr>
      <a:lvl6pPr marL="707231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6pPr>
      <a:lvl7pPr marL="835818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7pPr>
      <a:lvl8pPr marL="964406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8pPr>
      <a:lvl9pPr marL="1092993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28587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2pPr>
      <a:lvl3pPr marL="257175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385762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5pPr>
      <a:lvl6pPr marL="642937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6pPr>
      <a:lvl7pPr marL="771525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7pPr>
      <a:lvl8pPr marL="900112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8pPr>
      <a:lvl9pPr marL="1028700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Skupina 35"/>
          <p:cNvGrpSpPr/>
          <p:nvPr/>
        </p:nvGrpSpPr>
        <p:grpSpPr>
          <a:xfrm>
            <a:off x="180000" y="2439426"/>
            <a:ext cx="30131504" cy="6994779"/>
            <a:chOff x="-611504" y="1440000"/>
            <a:chExt cx="30131504" cy="6994779"/>
          </a:xfrm>
        </p:grpSpPr>
        <p:grpSp>
          <p:nvGrpSpPr>
            <p:cNvPr id="5" name="Skupina 4"/>
            <p:cNvGrpSpPr/>
            <p:nvPr/>
          </p:nvGrpSpPr>
          <p:grpSpPr>
            <a:xfrm>
              <a:off x="6120000" y="6734909"/>
              <a:ext cx="10800000" cy="1699870"/>
              <a:chOff x="1800000" y="4960130"/>
              <a:chExt cx="10800000" cy="1699870"/>
            </a:xfrm>
          </p:grpSpPr>
          <p:sp>
            <p:nvSpPr>
              <p:cNvPr id="25" name="Obdélník 24"/>
              <p:cNvSpPr/>
              <p:nvPr/>
            </p:nvSpPr>
            <p:spPr>
              <a:xfrm>
                <a:off x="1800000" y="6480000"/>
                <a:ext cx="10800000" cy="1800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6" name="Šipka doprava 25"/>
              <p:cNvSpPr/>
              <p:nvPr/>
            </p:nvSpPr>
            <p:spPr>
              <a:xfrm>
                <a:off x="2880000" y="6120000"/>
                <a:ext cx="540000" cy="283500"/>
              </a:xfrm>
              <a:prstGeom prst="rightArrow">
                <a:avLst/>
              </a:prstGeom>
              <a:solidFill>
                <a:srgbClr val="FF33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7" name="Šipka doprava 26"/>
              <p:cNvSpPr/>
              <p:nvPr/>
            </p:nvSpPr>
            <p:spPr>
              <a:xfrm>
                <a:off x="10080000" y="6120000"/>
                <a:ext cx="720000" cy="283500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8" name="TextovéPole 27"/>
              <p:cNvSpPr txBox="1"/>
              <p:nvPr/>
            </p:nvSpPr>
            <p:spPr>
              <a:xfrm rot="16200000">
                <a:off x="9864000" y="5408019"/>
                <a:ext cx="100811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opB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ovéPole 28"/>
              <p:cNvSpPr txBox="1"/>
              <p:nvPr/>
            </p:nvSpPr>
            <p:spPr>
              <a:xfrm rot="16200000">
                <a:off x="2556000" y="5338130"/>
                <a:ext cx="1152000" cy="39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cr-1.1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Skupina 5"/>
            <p:cNvGrpSpPr/>
            <p:nvPr/>
          </p:nvGrpSpPr>
          <p:grpSpPr>
            <a:xfrm>
              <a:off x="720000" y="1944112"/>
              <a:ext cx="28800000" cy="1810942"/>
              <a:chOff x="1800000" y="169333"/>
              <a:chExt cx="28800000" cy="1810942"/>
            </a:xfrm>
          </p:grpSpPr>
          <p:sp>
            <p:nvSpPr>
              <p:cNvPr id="13" name="Obdélník 12"/>
              <p:cNvSpPr/>
              <p:nvPr/>
            </p:nvSpPr>
            <p:spPr>
              <a:xfrm>
                <a:off x="1800000" y="1800275"/>
                <a:ext cx="28800000" cy="180000"/>
              </a:xfrm>
              <a:prstGeom prst="rect">
                <a:avLst/>
              </a:prstGeom>
              <a:solidFill>
                <a:srgbClr val="00FF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4" name="Obdélník 13"/>
              <p:cNvSpPr/>
              <p:nvPr/>
            </p:nvSpPr>
            <p:spPr>
              <a:xfrm>
                <a:off x="3960000" y="1800000"/>
                <a:ext cx="10008000" cy="1800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5" name="Šipka doprava 14"/>
              <p:cNvSpPr/>
              <p:nvPr/>
            </p:nvSpPr>
            <p:spPr>
              <a:xfrm>
                <a:off x="4680000" y="1440000"/>
                <a:ext cx="540000" cy="283500"/>
              </a:xfrm>
              <a:prstGeom prst="rightArrow">
                <a:avLst/>
              </a:prstGeom>
              <a:solidFill>
                <a:srgbClr val="FF33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6" name="Šipka doprava 15"/>
              <p:cNvSpPr/>
              <p:nvPr/>
            </p:nvSpPr>
            <p:spPr>
              <a:xfrm>
                <a:off x="14040000" y="1440000"/>
                <a:ext cx="720000" cy="283500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7" name="TextovéPole 16"/>
              <p:cNvSpPr txBox="1"/>
              <p:nvPr/>
            </p:nvSpPr>
            <p:spPr>
              <a:xfrm rot="16200000">
                <a:off x="13860000" y="691475"/>
                <a:ext cx="100811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opB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ovéPole 17"/>
              <p:cNvSpPr txBox="1"/>
              <p:nvPr/>
            </p:nvSpPr>
            <p:spPr>
              <a:xfrm rot="16200000">
                <a:off x="4320000" y="621586"/>
                <a:ext cx="1152000" cy="39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cr-1.1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Obdélník 18"/>
              <p:cNvSpPr/>
              <p:nvPr/>
            </p:nvSpPr>
            <p:spPr>
              <a:xfrm>
                <a:off x="1800000" y="1800000"/>
                <a:ext cx="540000" cy="1800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0" name="Šipka doprava 19"/>
              <p:cNvSpPr/>
              <p:nvPr/>
            </p:nvSpPr>
            <p:spPr>
              <a:xfrm rot="10800000">
                <a:off x="2340000" y="1440000"/>
                <a:ext cx="540000" cy="283500"/>
              </a:xfrm>
              <a:prstGeom prst="rightArrow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1" name="TextovéPole 20"/>
              <p:cNvSpPr txBox="1"/>
              <p:nvPr/>
            </p:nvSpPr>
            <p:spPr>
              <a:xfrm rot="16200000">
                <a:off x="1980000" y="583333"/>
                <a:ext cx="1224000" cy="39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a</a:t>
                </a:r>
                <a:r>
                  <a:rPr lang="en-US" sz="20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EM-32</a:t>
                </a:r>
                <a:endParaRPr lang="cs-CZ" sz="2000" i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Obdélník 21"/>
              <p:cNvSpPr/>
              <p:nvPr/>
            </p:nvSpPr>
            <p:spPr>
              <a:xfrm>
                <a:off x="29160000" y="1800000"/>
                <a:ext cx="1440000" cy="180000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3" name="Šipka doprava 22"/>
              <p:cNvSpPr/>
              <p:nvPr/>
            </p:nvSpPr>
            <p:spPr>
              <a:xfrm>
                <a:off x="29271600" y="1440000"/>
                <a:ext cx="720000" cy="283500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24" name="TextovéPole 23"/>
              <p:cNvSpPr txBox="1"/>
              <p:nvPr/>
            </p:nvSpPr>
            <p:spPr>
              <a:xfrm rot="16200000">
                <a:off x="29091600" y="689222"/>
                <a:ext cx="100811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opB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Skupina 6"/>
            <p:cNvGrpSpPr/>
            <p:nvPr/>
          </p:nvGrpSpPr>
          <p:grpSpPr>
            <a:xfrm>
              <a:off x="11448000" y="4680000"/>
              <a:ext cx="16632000" cy="1594779"/>
              <a:chOff x="12528000" y="2905221"/>
              <a:chExt cx="16632000" cy="1594779"/>
            </a:xfrm>
          </p:grpSpPr>
          <p:sp>
            <p:nvSpPr>
              <p:cNvPr id="10" name="Obdélník 9"/>
              <p:cNvSpPr/>
              <p:nvPr/>
            </p:nvSpPr>
            <p:spPr>
              <a:xfrm>
                <a:off x="12528000" y="4320000"/>
                <a:ext cx="16632000" cy="180000"/>
              </a:xfrm>
              <a:prstGeom prst="rect">
                <a:avLst/>
              </a:prstGeom>
              <a:solidFill>
                <a:srgbClr val="00FF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1" name="Šipka doprava 10"/>
              <p:cNvSpPr/>
              <p:nvPr/>
            </p:nvSpPr>
            <p:spPr>
              <a:xfrm>
                <a:off x="14040000" y="3960000"/>
                <a:ext cx="720000" cy="283500"/>
              </a:xfrm>
              <a:prstGeom prst="rightArrow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216027" tIns="108014" rIns="216027" bIns="108014" spcCol="0" rtlCol="0" anchor="ctr"/>
              <a:lstStyle/>
              <a:p>
                <a:pPr algn="ctr"/>
                <a:endParaRPr lang="cs-CZ"/>
              </a:p>
            </p:txBody>
          </p:sp>
          <p:sp>
            <p:nvSpPr>
              <p:cNvPr id="12" name="TextovéPole 11"/>
              <p:cNvSpPr txBox="1"/>
              <p:nvPr/>
            </p:nvSpPr>
            <p:spPr>
              <a:xfrm rot="16200000">
                <a:off x="13860000" y="3209222"/>
                <a:ext cx="100811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0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topB</a:t>
                </a:r>
                <a:endParaRPr lang="cs-CZ" sz="2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" name="Pravoúhlá spojnice 7"/>
            <p:cNvCxnSpPr/>
            <p:nvPr/>
          </p:nvCxnSpPr>
          <p:spPr>
            <a:xfrm rot="16200000" flipH="1">
              <a:off x="12527999" y="6562779"/>
              <a:ext cx="2160000" cy="1440000"/>
            </a:xfrm>
            <a:prstGeom prst="bentConnector3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Pravoúhlá spojnice 8"/>
            <p:cNvCxnSpPr/>
            <p:nvPr/>
          </p:nvCxnSpPr>
          <p:spPr>
            <a:xfrm rot="5400000">
              <a:off x="20592000" y="857341"/>
              <a:ext cx="2160000" cy="12780000"/>
            </a:xfrm>
            <a:prstGeom prst="bentConnector3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Přímá spojnice se šipkou 30"/>
            <p:cNvCxnSpPr/>
            <p:nvPr/>
          </p:nvCxnSpPr>
          <p:spPr>
            <a:xfrm rot="10800000">
              <a:off x="18902312" y="4187030"/>
              <a:ext cx="0" cy="1414399"/>
            </a:xfrm>
            <a:prstGeom prst="straightConnector1">
              <a:avLst/>
            </a:prstGeom>
            <a:ln w="889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ovéPole 29"/>
            <p:cNvSpPr txBox="1"/>
            <p:nvPr/>
          </p:nvSpPr>
          <p:spPr>
            <a:xfrm>
              <a:off x="7616106" y="5265167"/>
              <a:ext cx="40694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cI2 progenitor</a:t>
              </a:r>
              <a:endParaRPr lang="cs-CZ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ovéPole 31"/>
            <p:cNvSpPr txBox="1"/>
            <p:nvPr/>
          </p:nvSpPr>
          <p:spPr>
            <a:xfrm>
              <a:off x="1245494" y="7450832"/>
              <a:ext cx="54074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24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-1.1</a:t>
              </a:r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arrying IncX4 progenitor</a:t>
              </a:r>
              <a:endParaRPr lang="cs-CZ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ovéPole 32"/>
            <p:cNvSpPr txBox="1"/>
            <p:nvPr/>
          </p:nvSpPr>
          <p:spPr>
            <a:xfrm>
              <a:off x="-611504" y="1440000"/>
              <a:ext cx="406946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MCR1138_A1</a:t>
              </a:r>
              <a:endParaRPr lang="cs-CZ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TextovéPole 36"/>
          <p:cNvSpPr txBox="1"/>
          <p:nvPr/>
        </p:nvSpPr>
        <p:spPr>
          <a:xfrm>
            <a:off x="185349" y="351194"/>
            <a:ext cx="13315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cs-CZ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7797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5402" y="144116"/>
            <a:ext cx="13976033" cy="14039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ovéPole 5"/>
          <p:cNvSpPr txBox="1"/>
          <p:nvPr/>
        </p:nvSpPr>
        <p:spPr>
          <a:xfrm>
            <a:off x="15589944" y="11515978"/>
            <a:ext cx="1476164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 A) Schematic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on of fusion event, which may occurred and resulted in the formation of plasmid pMCR1138_A1. 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B) BRIG comparison of plasmid pMCR1138_A1 with IncX4 plasmid pMCR1525D1 and IncI2 plasmid pMCR1884_ C3. </a:t>
            </a:r>
            <a:endParaRPr lang="cs-CZ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ovéPole 6"/>
          <p:cNvSpPr txBox="1"/>
          <p:nvPr/>
        </p:nvSpPr>
        <p:spPr>
          <a:xfrm>
            <a:off x="185349" y="351194"/>
            <a:ext cx="13315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cs-CZ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68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58</Words>
  <Application>Microsoft Office PowerPoint</Application>
  <PresentationFormat>Vlastní</PresentationFormat>
  <Paragraphs>13</Paragraphs>
  <Slides>2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2</vt:i4>
      </vt:variant>
    </vt:vector>
  </HeadingPairs>
  <TitlesOfParts>
    <vt:vector size="3" baseType="lpstr">
      <vt:lpstr>Motiv systému Office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pagiannitsis</dc:creator>
  <cp:lastModifiedBy>papagiannitsis</cp:lastModifiedBy>
  <cp:revision>6</cp:revision>
  <dcterms:created xsi:type="dcterms:W3CDTF">2020-07-17T12:51:03Z</dcterms:created>
  <dcterms:modified xsi:type="dcterms:W3CDTF">2020-09-04T20:51:09Z</dcterms:modified>
</cp:coreProperties>
</file>